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75" d="100"/>
          <a:sy n="75" d="100"/>
        </p:scale>
        <p:origin x="84" y="4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nu\Downloads\171010_CCI%208&#5145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7701841243919376E-2"/>
          <c:y val="4.3598906047304063E-2"/>
          <c:w val="0.9535922756154902"/>
          <c:h val="0.90064281122328693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noFill/>
              <a:ln w="1905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171010_CCI 8주.xlsx]Sheet1'!$B$12,'[171010_CCI 8주.xlsx]Sheet1'!$E$12,'[171010_CCI 8주.xlsx]Sheet1'!$J$12,'[171010_CCI 8주.xlsx]Sheet1'!$O$12,'[171010_CCI 8주.xlsx]Sheet1'!$T$12,'[171010_CCI 8주.xlsx]Sheet1'!$Y$12,'[171010_CCI 8주.xlsx]Sheet1'!$AD$12,'[171010_CCI 8주.xlsx]Sheet1'!$AI$12,'[171010_CCI 8주.xlsx]Sheet1'!$AN$12</c:f>
                <c:numCache>
                  <c:formatCode>General</c:formatCode>
                  <c:ptCount val="9"/>
                  <c:pt idx="0">
                    <c:v>0.37193189340702354</c:v>
                  </c:pt>
                  <c:pt idx="1">
                    <c:v>0.37193189340702354</c:v>
                  </c:pt>
                  <c:pt idx="2">
                    <c:v>0.28394541729001438</c:v>
                  </c:pt>
                  <c:pt idx="3">
                    <c:v>8.6602540378443879E-2</c:v>
                  </c:pt>
                  <c:pt idx="4">
                    <c:v>7.5000000000000011E-2</c:v>
                  </c:pt>
                  <c:pt idx="5">
                    <c:v>8.6602540378443879E-2</c:v>
                  </c:pt>
                  <c:pt idx="6">
                    <c:v>7.5000000000000011E-2</c:v>
                  </c:pt>
                  <c:pt idx="7">
                    <c:v>8.6602540378443879E-2</c:v>
                  </c:pt>
                  <c:pt idx="8">
                    <c:v>7.5000000000000011E-2</c:v>
                  </c:pt>
                </c:numCache>
              </c:numRef>
            </c:plus>
            <c:minus>
              <c:numRef>
                <c:f>'[171010_CCI 8주.xlsx]Sheet1'!$B$12,'[171010_CCI 8주.xlsx]Sheet1'!$E$12,'[171010_CCI 8주.xlsx]Sheet1'!$J$12,'[171010_CCI 8주.xlsx]Sheet1'!$O$12,'[171010_CCI 8주.xlsx]Sheet1'!$T$12,'[171010_CCI 8주.xlsx]Sheet1'!$Y$12,'[171010_CCI 8주.xlsx]Sheet1'!$AD$12,'[171010_CCI 8주.xlsx]Sheet1'!$AI$12,'[171010_CCI 8주.xlsx]Sheet1'!$AN$12</c:f>
                <c:numCache>
                  <c:formatCode>General</c:formatCode>
                  <c:ptCount val="9"/>
                  <c:pt idx="0">
                    <c:v>0.37193189340702354</c:v>
                  </c:pt>
                  <c:pt idx="1">
                    <c:v>0.37193189340702354</c:v>
                  </c:pt>
                  <c:pt idx="2">
                    <c:v>0.28394541729001438</c:v>
                  </c:pt>
                  <c:pt idx="3">
                    <c:v>8.6602540378443879E-2</c:v>
                  </c:pt>
                  <c:pt idx="4">
                    <c:v>7.5000000000000011E-2</c:v>
                  </c:pt>
                  <c:pt idx="5">
                    <c:v>8.6602540378443879E-2</c:v>
                  </c:pt>
                  <c:pt idx="6">
                    <c:v>7.5000000000000011E-2</c:v>
                  </c:pt>
                  <c:pt idx="7">
                    <c:v>8.6602540378443879E-2</c:v>
                  </c:pt>
                  <c:pt idx="8">
                    <c:v>7.500000000000001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171010_CCI 8주.xlsx]Sheet1'!$B$21:$J$21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</c:numCache>
            </c:numRef>
          </c:xVal>
          <c:yVal>
            <c:numRef>
              <c:f>'[171010_CCI 8주.xlsx]Sheet1'!$B$22:$J$22</c:f>
              <c:numCache>
                <c:formatCode>General</c:formatCode>
                <c:ptCount val="9"/>
                <c:pt idx="0">
                  <c:v>1.9</c:v>
                </c:pt>
                <c:pt idx="1">
                  <c:v>1.9</c:v>
                </c:pt>
                <c:pt idx="2">
                  <c:v>2.1749999999999998</c:v>
                </c:pt>
                <c:pt idx="3">
                  <c:v>1.85</c:v>
                </c:pt>
                <c:pt idx="4">
                  <c:v>1.925</c:v>
                </c:pt>
                <c:pt idx="5">
                  <c:v>1.85</c:v>
                </c:pt>
                <c:pt idx="6">
                  <c:v>1.7749999999999999</c:v>
                </c:pt>
                <c:pt idx="7">
                  <c:v>1.85</c:v>
                </c:pt>
                <c:pt idx="8">
                  <c:v>1.775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FE8-4663-AD92-F13A4A4DA66F}"/>
            </c:ext>
          </c:extLst>
        </c:ser>
        <c:ser>
          <c:idx val="1"/>
          <c:order val="1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171010_CCI 8주.xlsx]Sheet1'!$B$12,'[171010_CCI 8주.xlsx]Sheet1'!$G$12,'[171010_CCI 8주.xlsx]Sheet1'!$L$12,'[171010_CCI 8주.xlsx]Sheet1'!$Q$12,'[171010_CCI 8주.xlsx]Sheet1'!$V$12,'[171010_CCI 8주.xlsx]Sheet1'!$AA$12,'[171010_CCI 8주.xlsx]Sheet1'!$AF$12,'[171010_CCI 8주.xlsx]Sheet1'!$AK$12,'[171010_CCI 8주.xlsx]Sheet1'!$AP$12</c:f>
                <c:numCache>
                  <c:formatCode>General</c:formatCode>
                  <c:ptCount val="9"/>
                  <c:pt idx="0">
                    <c:v>0.37193189340702354</c:v>
                  </c:pt>
                  <c:pt idx="1">
                    <c:v>7.8315600829805085E-2</c:v>
                  </c:pt>
                  <c:pt idx="2">
                    <c:v>0.10954451150103352</c:v>
                  </c:pt>
                  <c:pt idx="3">
                    <c:v>0.13490737563232036</c:v>
                  </c:pt>
                  <c:pt idx="4">
                    <c:v>0.15143755588800728</c:v>
                  </c:pt>
                  <c:pt idx="5">
                    <c:v>0.12569805089976541</c:v>
                  </c:pt>
                  <c:pt idx="6">
                    <c:v>0.14259499757471605</c:v>
                  </c:pt>
                  <c:pt idx="7">
                    <c:v>7.4833147735478736E-2</c:v>
                  </c:pt>
                  <c:pt idx="8">
                    <c:v>7.8740078740118166E-2</c:v>
                  </c:pt>
                </c:numCache>
              </c:numRef>
            </c:plus>
            <c:minus>
              <c:numRef>
                <c:f>'[171010_CCI 8주.xlsx]Sheet1'!$B$12,'[171010_CCI 8주.xlsx]Sheet1'!$G$12,'[171010_CCI 8주.xlsx]Sheet1'!$L$12,'[171010_CCI 8주.xlsx]Sheet1'!$Q$12,'[171010_CCI 8주.xlsx]Sheet1'!$V$12,'[171010_CCI 8주.xlsx]Sheet1'!$AA$12,'[171010_CCI 8주.xlsx]Sheet1'!$AF$12,'[171010_CCI 8주.xlsx]Sheet1'!$AK$12,'[171010_CCI 8주.xlsx]Sheet1'!$AP$12</c:f>
                <c:numCache>
                  <c:formatCode>General</c:formatCode>
                  <c:ptCount val="9"/>
                  <c:pt idx="0">
                    <c:v>0.37193189340702354</c:v>
                  </c:pt>
                  <c:pt idx="1">
                    <c:v>7.8315600829805085E-2</c:v>
                  </c:pt>
                  <c:pt idx="2">
                    <c:v>0.10954451150103352</c:v>
                  </c:pt>
                  <c:pt idx="3">
                    <c:v>0.13490737563232036</c:v>
                  </c:pt>
                  <c:pt idx="4">
                    <c:v>0.15143755588800728</c:v>
                  </c:pt>
                  <c:pt idx="5">
                    <c:v>0.12569805089976541</c:v>
                  </c:pt>
                  <c:pt idx="6">
                    <c:v>0.14259499757471605</c:v>
                  </c:pt>
                  <c:pt idx="7">
                    <c:v>7.4833147735478736E-2</c:v>
                  </c:pt>
                  <c:pt idx="8">
                    <c:v>7.874007874011816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171010_CCI 8주.xlsx]Sheet1'!$B$21:$J$21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</c:numCache>
            </c:numRef>
          </c:xVal>
          <c:yVal>
            <c:numRef>
              <c:f>'[171010_CCI 8주.xlsx]Sheet1'!$B$23:$J$23</c:f>
              <c:numCache>
                <c:formatCode>General</c:formatCode>
                <c:ptCount val="9"/>
                <c:pt idx="0">
                  <c:v>1.9</c:v>
                </c:pt>
                <c:pt idx="1">
                  <c:v>0.54999999999999993</c:v>
                </c:pt>
                <c:pt idx="2">
                  <c:v>0.38666666666666666</c:v>
                </c:pt>
                <c:pt idx="3">
                  <c:v>0.24000000000000002</c:v>
                </c:pt>
                <c:pt idx="4">
                  <c:v>0.27666666666666667</c:v>
                </c:pt>
                <c:pt idx="5">
                  <c:v>0.29666666666666669</c:v>
                </c:pt>
                <c:pt idx="6">
                  <c:v>0.41</c:v>
                </c:pt>
                <c:pt idx="7">
                  <c:v>0.35000000000000003</c:v>
                </c:pt>
                <c:pt idx="8">
                  <c:v>0.2566666666666666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FE8-4663-AD92-F13A4A4DA66F}"/>
            </c:ext>
          </c:extLst>
        </c:ser>
        <c:ser>
          <c:idx val="2"/>
          <c:order val="2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171010_CCI 8주.xlsx]Sheet1'!$B$12,'[171010_CCI 8주.xlsx]Sheet1'!$F$12,'[171010_CCI 8주.xlsx]Sheet1'!$K$12,'[171010_CCI 8주.xlsx]Sheet1'!$P$12,'[171010_CCI 8주.xlsx]Sheet1'!$U$12,'[171010_CCI 8주.xlsx]Sheet1'!$Z$12,'[171010_CCI 8주.xlsx]Sheet1'!$AE$12,'[171010_CCI 8주.xlsx]Sheet1'!$AJ$12,'[171010_CCI 8주.xlsx]Sheet1'!$AO$12</c:f>
                <c:numCache>
                  <c:formatCode>General</c:formatCode>
                  <c:ptCount val="9"/>
                  <c:pt idx="0">
                    <c:v>0.37193189340702354</c:v>
                  </c:pt>
                  <c:pt idx="1">
                    <c:v>8.0622577482985694E-2</c:v>
                  </c:pt>
                  <c:pt idx="2">
                    <c:v>7.3333333333333361E-2</c:v>
                  </c:pt>
                  <c:pt idx="3">
                    <c:v>2.5298221281347035E-2</c:v>
                  </c:pt>
                  <c:pt idx="4">
                    <c:v>2.8480012484391765E-2</c:v>
                  </c:pt>
                  <c:pt idx="5">
                    <c:v>1.6666666666666639E-2</c:v>
                  </c:pt>
                  <c:pt idx="6">
                    <c:v>4.4045431091090582E-2</c:v>
                  </c:pt>
                  <c:pt idx="7">
                    <c:v>5.5317266743757358E-2</c:v>
                  </c:pt>
                  <c:pt idx="8">
                    <c:v>5.4262735320332392E-2</c:v>
                  </c:pt>
                </c:numCache>
              </c:numRef>
            </c:plus>
            <c:minus>
              <c:numRef>
                <c:f>'[171010_CCI 8주.xlsx]Sheet1'!$B$12,'[171010_CCI 8주.xlsx]Sheet1'!$F$12,'[171010_CCI 8주.xlsx]Sheet1'!$K$12,'[171010_CCI 8주.xlsx]Sheet1'!$P$12,'[171010_CCI 8주.xlsx]Sheet1'!$U$12,'[171010_CCI 8주.xlsx]Sheet1'!$Z$12,'[171010_CCI 8주.xlsx]Sheet1'!$AE$12,'[171010_CCI 8주.xlsx]Sheet1'!$AJ$12,'[171010_CCI 8주.xlsx]Sheet1'!$AO$12</c:f>
                <c:numCache>
                  <c:formatCode>General</c:formatCode>
                  <c:ptCount val="9"/>
                  <c:pt idx="0">
                    <c:v>0.37193189340702354</c:v>
                  </c:pt>
                  <c:pt idx="1">
                    <c:v>8.0622577482985694E-2</c:v>
                  </c:pt>
                  <c:pt idx="2">
                    <c:v>7.3333333333333361E-2</c:v>
                  </c:pt>
                  <c:pt idx="3">
                    <c:v>2.5298221281347035E-2</c:v>
                  </c:pt>
                  <c:pt idx="4">
                    <c:v>2.8480012484391765E-2</c:v>
                  </c:pt>
                  <c:pt idx="5">
                    <c:v>1.6666666666666639E-2</c:v>
                  </c:pt>
                  <c:pt idx="6">
                    <c:v>4.4045431091090582E-2</c:v>
                  </c:pt>
                  <c:pt idx="7">
                    <c:v>5.5317266743757358E-2</c:v>
                  </c:pt>
                  <c:pt idx="8">
                    <c:v>5.426273532033239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171010_CCI 8주.xlsx]Sheet1'!$B$21:$J$21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</c:numCache>
            </c:numRef>
          </c:xVal>
          <c:yVal>
            <c:numRef>
              <c:f>'[171010_CCI 8주.xlsx]Sheet1'!$B$24:$J$24</c:f>
              <c:numCache>
                <c:formatCode>General</c:formatCode>
                <c:ptCount val="9"/>
                <c:pt idx="0">
                  <c:v>1.9</c:v>
                </c:pt>
                <c:pt idx="1">
                  <c:v>0.93333333333333324</c:v>
                </c:pt>
                <c:pt idx="2">
                  <c:v>1.0999999999999999</c:v>
                </c:pt>
                <c:pt idx="3">
                  <c:v>0.75</c:v>
                </c:pt>
                <c:pt idx="4">
                  <c:v>0.84666666666666668</c:v>
                </c:pt>
                <c:pt idx="5">
                  <c:v>0.95000000000000007</c:v>
                </c:pt>
                <c:pt idx="6">
                  <c:v>0.81666666666666676</c:v>
                </c:pt>
                <c:pt idx="7">
                  <c:v>1</c:v>
                </c:pt>
                <c:pt idx="8">
                  <c:v>0.950000000000000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FE8-4663-AD92-F13A4A4DA6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09771936"/>
        <c:axId val="1809769024"/>
      </c:scatterChart>
      <c:valAx>
        <c:axId val="1809771936"/>
        <c:scaling>
          <c:orientation val="minMax"/>
          <c:max val="8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09769024"/>
        <c:crosses val="autoZero"/>
        <c:crossBetween val="midCat"/>
      </c:valAx>
      <c:valAx>
        <c:axId val="18097690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09771936"/>
        <c:crosses val="autoZero"/>
        <c:crossBetween val="midCat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CBBD38-41CD-4243-B29C-F7FB53493491}" type="datetimeFigureOut">
              <a:rPr lang="en-US" smtClean="0"/>
              <a:t>3/29/2018</a:t>
            </a:fld>
            <a:endParaRPr 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2B8BAB-B4B2-44A0-A2BA-B1CCC6B3F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3235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DEA991-8EB4-437B-9F4C-AAF3F9C6C52D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8029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DEA991-8EB4-437B-9F4C-AAF3F9C6C52D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32468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9A257-E7DE-466F-A519-EC8429382806}" type="datetimeFigureOut">
              <a:rPr lang="en-US" smtClean="0"/>
              <a:t>3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C90D-2A1C-468F-9C70-39843D7EA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695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9A257-E7DE-466F-A519-EC8429382806}" type="datetimeFigureOut">
              <a:rPr lang="en-US" smtClean="0"/>
              <a:t>3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C90D-2A1C-468F-9C70-39843D7EA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259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9A257-E7DE-466F-A519-EC8429382806}" type="datetimeFigureOut">
              <a:rPr lang="en-US" smtClean="0"/>
              <a:t>3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C90D-2A1C-468F-9C70-39843D7EA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797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9A257-E7DE-466F-A519-EC8429382806}" type="datetimeFigureOut">
              <a:rPr lang="en-US" smtClean="0"/>
              <a:t>3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C90D-2A1C-468F-9C70-39843D7EA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076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9A257-E7DE-466F-A519-EC8429382806}" type="datetimeFigureOut">
              <a:rPr lang="en-US" smtClean="0"/>
              <a:t>3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C90D-2A1C-468F-9C70-39843D7EA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6544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9A257-E7DE-466F-A519-EC8429382806}" type="datetimeFigureOut">
              <a:rPr lang="en-US" smtClean="0"/>
              <a:t>3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C90D-2A1C-468F-9C70-39843D7EA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906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9A257-E7DE-466F-A519-EC8429382806}" type="datetimeFigureOut">
              <a:rPr lang="en-US" smtClean="0"/>
              <a:t>3/2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C90D-2A1C-468F-9C70-39843D7EA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940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9A257-E7DE-466F-A519-EC8429382806}" type="datetimeFigureOut">
              <a:rPr lang="en-US" smtClean="0"/>
              <a:t>3/2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C90D-2A1C-468F-9C70-39843D7EA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167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9A257-E7DE-466F-A519-EC8429382806}" type="datetimeFigureOut">
              <a:rPr lang="en-US" smtClean="0"/>
              <a:t>3/2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C90D-2A1C-468F-9C70-39843D7EA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785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9A257-E7DE-466F-A519-EC8429382806}" type="datetimeFigureOut">
              <a:rPr lang="en-US" smtClean="0"/>
              <a:t>3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C90D-2A1C-468F-9C70-39843D7EA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8561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C9A257-E7DE-466F-A519-EC8429382806}" type="datetimeFigureOut">
              <a:rPr lang="en-US" smtClean="0"/>
              <a:t>3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99C90D-2A1C-468F-9C70-39843D7EA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8632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C9A257-E7DE-466F-A519-EC8429382806}" type="datetimeFigureOut">
              <a:rPr lang="en-US" smtClean="0"/>
              <a:t>3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99C90D-2A1C-468F-9C70-39843D7EA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517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2"/>
            <a:ext cx="19666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Supplementary Figure 1.</a:t>
            </a:r>
            <a:endParaRPr lang="ko-KR" altLang="en-US" sz="1400" dirty="0"/>
          </a:p>
        </p:txBody>
      </p:sp>
      <p:grpSp>
        <p:nvGrpSpPr>
          <p:cNvPr id="33" name="그룹 32"/>
          <p:cNvGrpSpPr/>
          <p:nvPr/>
        </p:nvGrpSpPr>
        <p:grpSpPr>
          <a:xfrm>
            <a:off x="1674799" y="1556239"/>
            <a:ext cx="6187494" cy="3479550"/>
            <a:chOff x="1977504" y="1549020"/>
            <a:chExt cx="5220755" cy="2755232"/>
          </a:xfrm>
        </p:grpSpPr>
        <p:graphicFrame>
          <p:nvGraphicFramePr>
            <p:cNvPr id="3" name="차트 2"/>
            <p:cNvGraphicFramePr>
              <a:graphicFrameLocks/>
            </p:cNvGraphicFramePr>
            <p:nvPr>
              <p:extLst/>
            </p:nvPr>
          </p:nvGraphicFramePr>
          <p:xfrm>
            <a:off x="2247867" y="1549020"/>
            <a:ext cx="3801168" cy="261346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9" name="직사각형 18"/>
            <p:cNvSpPr/>
            <p:nvPr/>
          </p:nvSpPr>
          <p:spPr>
            <a:xfrm rot="16200000">
              <a:off x="1349003" y="2655117"/>
              <a:ext cx="1477737" cy="22073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1100" b="0" i="0" u="none" strike="noStrike" kern="1200" baseline="0">
                  <a:solidFill>
                    <a:prstClr val="black"/>
                  </a:solidFill>
                  <a:latin typeface="+mn-lt"/>
                  <a:ea typeface="+mn-ea"/>
                  <a:cs typeface="Arial" pitchFamily="34" charset="0"/>
                </a:defRPr>
              </a:pPr>
              <a:r>
                <a:rPr lang="en-US" altLang="ko-KR" sz="1100" dirty="0"/>
                <a:t>Paw withdrawal threshold (g)</a:t>
              </a:r>
              <a:endParaRPr lang="ko-KR" altLang="en-US" sz="1100" dirty="0"/>
            </a:p>
          </p:txBody>
        </p:sp>
        <p:sp>
          <p:nvSpPr>
            <p:cNvPr id="20" name="직사각형 19"/>
            <p:cNvSpPr/>
            <p:nvPr/>
          </p:nvSpPr>
          <p:spPr>
            <a:xfrm>
              <a:off x="3948906" y="4084914"/>
              <a:ext cx="511209" cy="2193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b="1" dirty="0"/>
                <a:t>Weeks</a:t>
              </a:r>
              <a:endParaRPr lang="ko-KR" altLang="en-US" sz="1200" b="1" dirty="0"/>
            </a:p>
          </p:txBody>
        </p:sp>
        <p:cxnSp>
          <p:nvCxnSpPr>
            <p:cNvPr id="21" name="구부러진 연결선 20"/>
            <p:cNvCxnSpPr/>
            <p:nvPr/>
          </p:nvCxnSpPr>
          <p:spPr>
            <a:xfrm>
              <a:off x="6018515" y="2545451"/>
              <a:ext cx="137832" cy="12226"/>
            </a:xfrm>
            <a:prstGeom prst="curvedConnector3">
              <a:avLst>
                <a:gd name="adj1" fmla="val 50000"/>
              </a:avLst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구부러진 연결선 21"/>
            <p:cNvCxnSpPr/>
            <p:nvPr/>
          </p:nvCxnSpPr>
          <p:spPr>
            <a:xfrm>
              <a:off x="6036677" y="3719638"/>
              <a:ext cx="137832" cy="12226"/>
            </a:xfrm>
            <a:prstGeom prst="curvedConnector3">
              <a:avLst>
                <a:gd name="adj1" fmla="val 50000"/>
              </a:avLst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구부러진 연결선 22"/>
            <p:cNvCxnSpPr/>
            <p:nvPr/>
          </p:nvCxnSpPr>
          <p:spPr>
            <a:xfrm>
              <a:off x="6053217" y="3182789"/>
              <a:ext cx="137832" cy="12226"/>
            </a:xfrm>
            <a:prstGeom prst="curvedConnector3">
              <a:avLst>
                <a:gd name="adj1" fmla="val 50000"/>
              </a:avLst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6018515" y="3070730"/>
              <a:ext cx="997235" cy="20715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dirty="0">
                  <a:solidFill>
                    <a:prstClr val="black"/>
                  </a:solidFill>
                  <a:cs typeface="Arial" pitchFamily="34" charset="0"/>
                </a:rPr>
                <a:t>pCK-HGF-X7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903378" y="3602138"/>
              <a:ext cx="848872" cy="20715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dirty="0" err="1">
                  <a:solidFill>
                    <a:prstClr val="black"/>
                  </a:solidFill>
                  <a:cs typeface="Arial" pitchFamily="34" charset="0"/>
                </a:rPr>
                <a:t>pCK</a:t>
              </a:r>
              <a:endParaRPr lang="en-US" altLang="ko-KR" sz="1100" dirty="0">
                <a:solidFill>
                  <a:prstClr val="black"/>
                </a:solidFill>
                <a:cs typeface="Arial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087431" y="2358950"/>
              <a:ext cx="689162" cy="27417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ko-KR" sz="1100" dirty="0">
                  <a:solidFill>
                    <a:prstClr val="black"/>
                  </a:solidFill>
                  <a:cs typeface="Arial" pitchFamily="34" charset="0"/>
                </a:rPr>
                <a:t>Sham</a:t>
              </a:r>
            </a:p>
          </p:txBody>
        </p:sp>
        <p:sp>
          <p:nvSpPr>
            <p:cNvPr id="27" name="오른쪽 대괄호 26"/>
            <p:cNvSpPr/>
            <p:nvPr/>
          </p:nvSpPr>
          <p:spPr>
            <a:xfrm>
              <a:off x="6809143" y="3099047"/>
              <a:ext cx="76407" cy="709236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885550" y="3358500"/>
              <a:ext cx="312709" cy="2071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/>
                <a:t>CCI</a:t>
              </a:r>
              <a:endParaRPr lang="ko-KR" altLang="en-US" sz="1100" dirty="0"/>
            </a:p>
          </p:txBody>
        </p:sp>
      </p:grpSp>
      <p:sp>
        <p:nvSpPr>
          <p:cNvPr id="15" name="TextBox 14"/>
          <p:cNvSpPr txBox="1"/>
          <p:nvPr/>
        </p:nvSpPr>
        <p:spPr>
          <a:xfrm>
            <a:off x="3205761" y="3157488"/>
            <a:ext cx="241815" cy="3205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724893" y="3513750"/>
            <a:ext cx="286359" cy="3205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740917" y="3299006"/>
            <a:ext cx="286359" cy="3205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259269" y="3337152"/>
            <a:ext cx="286359" cy="3205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*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2566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610394" y="1539346"/>
            <a:ext cx="418602" cy="4632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/>
              <a:t>A</a:t>
            </a:r>
            <a:endParaRPr lang="ko-KR" altLang="en-US" sz="2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946935" y="1539346"/>
            <a:ext cx="416575" cy="4632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/>
              <a:t>B</a:t>
            </a:r>
            <a:endParaRPr lang="ko-KR" altLang="en-US" sz="2400" b="1" dirty="0"/>
          </a:p>
        </p:txBody>
      </p:sp>
      <p:graphicFrame>
        <p:nvGraphicFramePr>
          <p:cNvPr id="16" name="개체 15"/>
          <p:cNvGraphicFramePr>
            <a:graphicFrameLocks noChangeAspect="1"/>
          </p:cNvGraphicFramePr>
          <p:nvPr>
            <p:extLst/>
          </p:nvPr>
        </p:nvGraphicFramePr>
        <p:xfrm>
          <a:off x="326904" y="1934437"/>
          <a:ext cx="4408488" cy="2771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7" r:id="rId4" imgW="4409142" imgH="2771745" progId="Prism7.Document">
                  <p:embed/>
                </p:oleObj>
              </mc:Choice>
              <mc:Fallback>
                <p:oleObj name="Prism 7" r:id="rId4" imgW="4409142" imgH="2771745" progId="Prism7.Document">
                  <p:embed/>
                  <p:pic>
                    <p:nvPicPr>
                      <p:cNvPr id="16" name="개체 15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6904" y="1934437"/>
                        <a:ext cx="4408488" cy="2771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개체 16"/>
          <p:cNvGraphicFramePr>
            <a:graphicFrameLocks noChangeAspect="1"/>
          </p:cNvGraphicFramePr>
          <p:nvPr>
            <p:extLst/>
          </p:nvPr>
        </p:nvGraphicFramePr>
        <p:xfrm>
          <a:off x="4661418" y="1948654"/>
          <a:ext cx="4291013" cy="3027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7" r:id="rId6" imgW="4290297" imgH="3027815" progId="Prism7.Document">
                  <p:embed/>
                </p:oleObj>
              </mc:Choice>
              <mc:Fallback>
                <p:oleObj name="Prism 7" r:id="rId6" imgW="4290297" imgH="3027815" progId="Prism7.Document">
                  <p:embed/>
                  <p:pic>
                    <p:nvPicPr>
                      <p:cNvPr id="17" name="개체 16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661418" y="1948654"/>
                        <a:ext cx="4291013" cy="3027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 rot="10800000">
            <a:off x="327593" y="2621040"/>
            <a:ext cx="369332" cy="1122615"/>
          </a:xfrm>
          <a:prstGeom prst="rect">
            <a:avLst/>
          </a:prstGeom>
          <a:solidFill>
            <a:schemeClr val="bg1"/>
          </a:solidFill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cs typeface="Times New Roman" panose="02020603050405020304" pitchFamily="18" charset="0"/>
              </a:rPr>
              <a:t>    Frequency (%)</a:t>
            </a:r>
            <a:endParaRPr lang="ko-KR" altLang="en-US" sz="1200" dirty="0"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0800000">
            <a:off x="4614059" y="2790724"/>
            <a:ext cx="369332" cy="829843"/>
          </a:xfrm>
          <a:prstGeom prst="rect">
            <a:avLst/>
          </a:prstGeom>
          <a:solidFill>
            <a:schemeClr val="bg1"/>
          </a:solidFill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cs typeface="Times New Roman" panose="02020603050405020304" pitchFamily="18" charset="0"/>
              </a:rPr>
              <a:t>Latency (s)  </a:t>
            </a:r>
            <a:endParaRPr lang="ko-KR" altLang="en-US" sz="1200" dirty="0"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129119" y="4123682"/>
            <a:ext cx="2672705" cy="64633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Day3                  Day 7                Day 14</a:t>
            </a:r>
          </a:p>
          <a:p>
            <a:endParaRPr lang="en-US" altLang="ko-KR" sz="1200" dirty="0"/>
          </a:p>
          <a:p>
            <a:endParaRPr lang="en-US" altLang="ko-KR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5344480" y="4160323"/>
            <a:ext cx="2672705" cy="64633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Day3                  Day 7                Day 14</a:t>
            </a:r>
          </a:p>
          <a:p>
            <a:endParaRPr lang="en-US" altLang="ko-KR" sz="1200" dirty="0"/>
          </a:p>
          <a:p>
            <a:endParaRPr lang="en-US" altLang="ko-KR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3779445" y="1928085"/>
            <a:ext cx="939021" cy="147732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200" dirty="0"/>
              <a:t>PBS</a:t>
            </a:r>
          </a:p>
          <a:p>
            <a:pPr>
              <a:lnSpc>
                <a:spcPct val="150000"/>
              </a:lnSpc>
            </a:pPr>
            <a:r>
              <a:rPr lang="en-US" altLang="ko-KR" sz="1200" dirty="0" err="1"/>
              <a:t>pCK</a:t>
            </a:r>
            <a:endParaRPr lang="en-US" altLang="ko-KR" sz="1200" dirty="0"/>
          </a:p>
          <a:p>
            <a:pPr>
              <a:lnSpc>
                <a:spcPct val="150000"/>
              </a:lnSpc>
            </a:pPr>
            <a:r>
              <a:rPr lang="en-US" altLang="ko-KR" sz="1200" dirty="0"/>
              <a:t>pCK-HGF-X7</a:t>
            </a:r>
          </a:p>
          <a:p>
            <a:pPr>
              <a:lnSpc>
                <a:spcPct val="150000"/>
              </a:lnSpc>
            </a:pPr>
            <a:endParaRPr lang="en-US" altLang="ko-KR" sz="1200" dirty="0"/>
          </a:p>
          <a:p>
            <a:pPr>
              <a:lnSpc>
                <a:spcPct val="150000"/>
              </a:lnSpc>
            </a:pPr>
            <a:endParaRPr lang="en-US" altLang="ko-KR" sz="1200" dirty="0"/>
          </a:p>
        </p:txBody>
      </p:sp>
      <p:sp>
        <p:nvSpPr>
          <p:cNvPr id="2" name="직사각형 1"/>
          <p:cNvSpPr/>
          <p:nvPr/>
        </p:nvSpPr>
        <p:spPr>
          <a:xfrm>
            <a:off x="7947623" y="2468482"/>
            <a:ext cx="881973" cy="34624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100" dirty="0"/>
              <a:t>pCK-HGF-X7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947623" y="1969221"/>
            <a:ext cx="939021" cy="34624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100" dirty="0"/>
              <a:t>PBS</a:t>
            </a:r>
          </a:p>
        </p:txBody>
      </p:sp>
      <p:sp>
        <p:nvSpPr>
          <p:cNvPr id="3" name="직사각형 2"/>
          <p:cNvSpPr/>
          <p:nvPr/>
        </p:nvSpPr>
        <p:spPr>
          <a:xfrm>
            <a:off x="7947621" y="2210390"/>
            <a:ext cx="407484" cy="34624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100" dirty="0" err="1"/>
              <a:t>pCK</a:t>
            </a:r>
            <a:endParaRPr lang="en-US" altLang="ko-KR" sz="1100" dirty="0"/>
          </a:p>
        </p:txBody>
      </p:sp>
      <p:sp>
        <p:nvSpPr>
          <p:cNvPr id="20" name="직사각형 19"/>
          <p:cNvSpPr/>
          <p:nvPr/>
        </p:nvSpPr>
        <p:spPr>
          <a:xfrm>
            <a:off x="3771413" y="2447915"/>
            <a:ext cx="881973" cy="34624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100" dirty="0"/>
              <a:t>pCK-HGF-X7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771413" y="1948654"/>
            <a:ext cx="939021" cy="34624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100" dirty="0"/>
              <a:t>PBS</a:t>
            </a:r>
          </a:p>
        </p:txBody>
      </p:sp>
      <p:sp>
        <p:nvSpPr>
          <p:cNvPr id="22" name="직사각형 21"/>
          <p:cNvSpPr/>
          <p:nvPr/>
        </p:nvSpPr>
        <p:spPr>
          <a:xfrm>
            <a:off x="3771411" y="2189823"/>
            <a:ext cx="407484" cy="34624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100" dirty="0" err="1"/>
              <a:t>pCK</a:t>
            </a:r>
            <a:endParaRPr lang="en-US" altLang="ko-KR" sz="1100" dirty="0"/>
          </a:p>
        </p:txBody>
      </p:sp>
      <p:sp>
        <p:nvSpPr>
          <p:cNvPr id="23" name="TextBox 22"/>
          <p:cNvSpPr txBox="1"/>
          <p:nvPr/>
        </p:nvSpPr>
        <p:spPr>
          <a:xfrm>
            <a:off x="-33490" y="-16044"/>
            <a:ext cx="19666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Supplementary Figure 2.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7489278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3</Words>
  <Application>Microsoft Office PowerPoint</Application>
  <PresentationFormat>화면 슬라이드 쇼(4:3)</PresentationFormat>
  <Paragraphs>29</Paragraphs>
  <Slides>2</Slides>
  <Notes>2</Notes>
  <HiddenSlides>0</HiddenSlides>
  <MMClips>0</MMClips>
  <ScaleCrop>false</ScaleCrop>
  <HeadingPairs>
    <vt:vector size="8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9" baseType="lpstr">
      <vt:lpstr>맑은 고딕</vt:lpstr>
      <vt:lpstr>Arial</vt:lpstr>
      <vt:lpstr>Calibri</vt:lpstr>
      <vt:lpstr>Calibri Light</vt:lpstr>
      <vt:lpstr>Times New Roman</vt:lpstr>
      <vt:lpstr>Office 테마</vt:lpstr>
      <vt:lpstr>Prism 7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nu</dc:creator>
  <cp:lastModifiedBy>snu</cp:lastModifiedBy>
  <cp:revision>1</cp:revision>
  <dcterms:created xsi:type="dcterms:W3CDTF">2018-03-29T04:35:42Z</dcterms:created>
  <dcterms:modified xsi:type="dcterms:W3CDTF">2018-03-29T04:35:58Z</dcterms:modified>
</cp:coreProperties>
</file>